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howGuides="1">
      <p:cViewPr varScale="1">
        <p:scale>
          <a:sx n="71" d="100"/>
          <a:sy n="71" d="100"/>
        </p:scale>
        <p:origin x="618" y="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A6135-5A40-410E-A6A4-B97777B7E890}" type="datetimeFigureOut">
              <a:rPr lang="en-US" smtClean="0"/>
              <a:t>7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8E4D3-9623-4E32-8A73-73D5D01172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99832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A6135-5A40-410E-A6A4-B97777B7E890}" type="datetimeFigureOut">
              <a:rPr lang="en-US" smtClean="0"/>
              <a:t>7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8E4D3-9623-4E32-8A73-73D5D01172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0072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A6135-5A40-410E-A6A4-B97777B7E890}" type="datetimeFigureOut">
              <a:rPr lang="en-US" smtClean="0"/>
              <a:t>7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8E4D3-9623-4E32-8A73-73D5D01172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9014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A6135-5A40-410E-A6A4-B97777B7E890}" type="datetimeFigureOut">
              <a:rPr lang="en-US" smtClean="0"/>
              <a:t>7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8E4D3-9623-4E32-8A73-73D5D01172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97854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A6135-5A40-410E-A6A4-B97777B7E890}" type="datetimeFigureOut">
              <a:rPr lang="en-US" smtClean="0"/>
              <a:t>7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8E4D3-9623-4E32-8A73-73D5D01172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307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A6135-5A40-410E-A6A4-B97777B7E890}" type="datetimeFigureOut">
              <a:rPr lang="en-US" smtClean="0"/>
              <a:t>7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8E4D3-9623-4E32-8A73-73D5D01172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5472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A6135-5A40-410E-A6A4-B97777B7E890}" type="datetimeFigureOut">
              <a:rPr lang="en-US" smtClean="0"/>
              <a:t>7/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8E4D3-9623-4E32-8A73-73D5D01172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27276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A6135-5A40-410E-A6A4-B97777B7E890}" type="datetimeFigureOut">
              <a:rPr lang="en-US" smtClean="0"/>
              <a:t>7/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8E4D3-9623-4E32-8A73-73D5D01172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54754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A6135-5A40-410E-A6A4-B97777B7E890}" type="datetimeFigureOut">
              <a:rPr lang="en-US" smtClean="0"/>
              <a:t>7/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8E4D3-9623-4E32-8A73-73D5D01172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726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A6135-5A40-410E-A6A4-B97777B7E890}" type="datetimeFigureOut">
              <a:rPr lang="en-US" smtClean="0"/>
              <a:t>7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8E4D3-9623-4E32-8A73-73D5D01172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6973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A6135-5A40-410E-A6A4-B97777B7E890}" type="datetimeFigureOut">
              <a:rPr lang="en-US" smtClean="0"/>
              <a:t>7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8E4D3-9623-4E32-8A73-73D5D01172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6496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2A6135-5A40-410E-A6A4-B97777B7E890}" type="datetimeFigureOut">
              <a:rPr lang="en-US" smtClean="0"/>
              <a:t>7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E8E4D3-9623-4E32-8A73-73D5D01172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66944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1025" name="Picture 8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9708" y="228600"/>
            <a:ext cx="11352584" cy="57053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0" y="341947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131676" y="5942079"/>
            <a:ext cx="11928648" cy="8793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marR="269875" algn="just">
              <a:lnSpc>
                <a:spcPct val="150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b="1" dirty="0" smtClean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dirty="0" smtClean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Quantitative real-time gene expression analysis of </a:t>
            </a:r>
            <a:r>
              <a:rPr lang="en-US" i="1" dirty="0" smtClean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lAREB1</a:t>
            </a:r>
            <a:r>
              <a:rPr lang="en-US" dirty="0" smtClean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in different transgenic lines used in this study. Values are means ± SD of three technical replicates.</a:t>
            </a:r>
            <a:endParaRPr lang="en-US" dirty="0"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189288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356" y="152636"/>
            <a:ext cx="11197244" cy="5408919"/>
          </a:xfrm>
          <a:prstGeom prst="rect">
            <a:avLst/>
          </a:prstGeom>
          <a:noFill/>
        </p:spPr>
      </p:pic>
      <p:sp>
        <p:nvSpPr>
          <p:cNvPr id="5" name="Rectangle 4"/>
          <p:cNvSpPr/>
          <p:nvPr/>
        </p:nvSpPr>
        <p:spPr>
          <a:xfrm>
            <a:off x="-96688" y="5561555"/>
            <a:ext cx="12192000" cy="12964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marR="269875" algn="just">
              <a:lnSpc>
                <a:spcPct val="150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b="1" dirty="0" smtClean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  <a:r>
              <a:rPr lang="en-US" dirty="0" smtClean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oisture content (%) of encapsulated-dehydrated beads of non-cryopreserved shoots tips of negative control, SlAREB1#2, SlAREB1#3 transgenic tomato plants as affected by air dehydration duration after pretreatment with 0.4 and 0.8 M sucrose concentration for one or three days.</a:t>
            </a:r>
            <a:endParaRPr lang="en-US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277304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9</TotalTime>
  <Words>74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c</dc:creator>
  <cp:lastModifiedBy>pc</cp:lastModifiedBy>
  <cp:revision>3</cp:revision>
  <dcterms:created xsi:type="dcterms:W3CDTF">2017-07-07T07:54:35Z</dcterms:created>
  <dcterms:modified xsi:type="dcterms:W3CDTF">2017-07-07T09:04:03Z</dcterms:modified>
</cp:coreProperties>
</file>